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248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3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7544CF6-AE63-4B07-AE99-7368339522C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2201"/>
            <a:ext cx="6858000" cy="7106724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D2B267E-A46F-48B5-847D-514C8A6D86BA}"/>
              </a:ext>
            </a:extLst>
          </p:cNvPr>
          <p:cNvSpPr/>
          <p:nvPr/>
        </p:nvSpPr>
        <p:spPr>
          <a:xfrm>
            <a:off x="6159500" y="575701"/>
            <a:ext cx="648000" cy="39960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112E794-1DDE-4146-81C5-289BDD3A1AB2}"/>
              </a:ext>
            </a:extLst>
          </p:cNvPr>
          <p:cNvSpPr/>
          <p:nvPr/>
        </p:nvSpPr>
        <p:spPr>
          <a:xfrm>
            <a:off x="6156975" y="4571994"/>
            <a:ext cx="648000" cy="18720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F0DF18B3-4517-48C9-A020-EDB809301C6C}"/>
              </a:ext>
            </a:extLst>
          </p:cNvPr>
          <p:cNvSpPr/>
          <p:nvPr/>
        </p:nvSpPr>
        <p:spPr>
          <a:xfrm>
            <a:off x="6156975" y="6436633"/>
            <a:ext cx="648000" cy="7560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4724C88-D803-4E31-8F94-7C0ECDBED221}"/>
              </a:ext>
            </a:extLst>
          </p:cNvPr>
          <p:cNvSpPr txBox="1"/>
          <p:nvPr/>
        </p:nvSpPr>
        <p:spPr>
          <a:xfrm>
            <a:off x="6099925" y="902938"/>
            <a:ext cx="7746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TMI group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5182767-6CE2-4851-8BE6-0553267C41AC}"/>
              </a:ext>
            </a:extLst>
          </p:cNvPr>
          <p:cNvSpPr txBox="1"/>
          <p:nvPr/>
        </p:nvSpPr>
        <p:spPr>
          <a:xfrm>
            <a:off x="6112625" y="5302352"/>
            <a:ext cx="7746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MP-MIP group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CEBCE63-6111-410B-B73E-10D191EAE654}"/>
              </a:ext>
            </a:extLst>
          </p:cNvPr>
          <p:cNvSpPr txBox="1"/>
          <p:nvPr/>
        </p:nvSpPr>
        <p:spPr>
          <a:xfrm>
            <a:off x="6087225" y="6559903"/>
            <a:ext cx="7873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/>
              <a:t>Myongo</a:t>
            </a:r>
            <a:r>
              <a:rPr kumimoji="1" lang="en-US" altLang="ja-JP" sz="1400" dirty="0"/>
              <a:t> group</a:t>
            </a:r>
            <a:endParaRPr kumimoji="1" lang="ja-JP" altLang="en-US" sz="1400" dirty="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44AE4B94-7986-4764-A7C3-231ABD1D06C9}"/>
              </a:ext>
            </a:extLst>
          </p:cNvPr>
          <p:cNvSpPr/>
          <p:nvPr/>
        </p:nvSpPr>
        <p:spPr>
          <a:xfrm>
            <a:off x="6156975" y="7188607"/>
            <a:ext cx="648000" cy="39600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7E5E646-789F-4990-A2F6-CB18A0749E91}"/>
              </a:ext>
            </a:extLst>
          </p:cNvPr>
          <p:cNvSpPr txBox="1"/>
          <p:nvPr/>
        </p:nvSpPr>
        <p:spPr>
          <a:xfrm>
            <a:off x="6070601" y="7200159"/>
            <a:ext cx="787399" cy="32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kumimoji="1" lang="en-US" altLang="ja-JP" sz="1000" dirty="0"/>
              <a:t>Miscella-</a:t>
            </a:r>
            <a:r>
              <a:rPr kumimoji="1" lang="en-US" altLang="ja-JP" sz="1000" dirty="0" err="1"/>
              <a:t>neous</a:t>
            </a:r>
            <a:endParaRPr kumimoji="1" lang="ja-JP" altLang="en-US" sz="1000" dirty="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87780141-C88A-43E2-9EF5-87AB549CB4E2}"/>
              </a:ext>
            </a:extLst>
          </p:cNvPr>
          <p:cNvSpPr/>
          <p:nvPr/>
        </p:nvSpPr>
        <p:spPr>
          <a:xfrm>
            <a:off x="4939780" y="1074420"/>
            <a:ext cx="432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F6113482-0424-4643-A83C-7DBCFD4EAD74}"/>
              </a:ext>
            </a:extLst>
          </p:cNvPr>
          <p:cNvSpPr/>
          <p:nvPr/>
        </p:nvSpPr>
        <p:spPr>
          <a:xfrm>
            <a:off x="5263630" y="1844040"/>
            <a:ext cx="432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A598158E-1DBC-4E99-B4A3-91DACF6ACC2F}"/>
              </a:ext>
            </a:extLst>
          </p:cNvPr>
          <p:cNvSpPr/>
          <p:nvPr/>
        </p:nvSpPr>
        <p:spPr>
          <a:xfrm>
            <a:off x="5191630" y="4795174"/>
            <a:ext cx="504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B72FAD83-FC1E-4F84-B07B-95604B4CCC69}"/>
              </a:ext>
            </a:extLst>
          </p:cNvPr>
          <p:cNvSpPr/>
          <p:nvPr/>
        </p:nvSpPr>
        <p:spPr>
          <a:xfrm>
            <a:off x="4882310" y="3775562"/>
            <a:ext cx="432000" cy="1363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BB64FF4E-C5BA-443B-B25D-4E486362F725}"/>
              </a:ext>
            </a:extLst>
          </p:cNvPr>
          <p:cNvSpPr/>
          <p:nvPr/>
        </p:nvSpPr>
        <p:spPr>
          <a:xfrm>
            <a:off x="5218300" y="5301904"/>
            <a:ext cx="324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33909543-7BED-4029-8247-65D3E9D6BD43}"/>
              </a:ext>
            </a:extLst>
          </p:cNvPr>
          <p:cNvSpPr/>
          <p:nvPr/>
        </p:nvSpPr>
        <p:spPr>
          <a:xfrm>
            <a:off x="5184010" y="5553364"/>
            <a:ext cx="324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353C9DDD-3B3B-4A6B-8E84-CEFE465B56A9}"/>
              </a:ext>
            </a:extLst>
          </p:cNvPr>
          <p:cNvSpPr/>
          <p:nvPr/>
        </p:nvSpPr>
        <p:spPr>
          <a:xfrm>
            <a:off x="5176390" y="5694334"/>
            <a:ext cx="324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AD9D29E-2E8C-42CF-A90F-19BC82A4A1CA}"/>
              </a:ext>
            </a:extLst>
          </p:cNvPr>
          <p:cNvSpPr/>
          <p:nvPr/>
        </p:nvSpPr>
        <p:spPr>
          <a:xfrm>
            <a:off x="4714670" y="3630782"/>
            <a:ext cx="540000" cy="1363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ACD29060-9DA3-418A-9E94-A42A151788B7}"/>
              </a:ext>
            </a:extLst>
          </p:cNvPr>
          <p:cNvSpPr/>
          <p:nvPr/>
        </p:nvSpPr>
        <p:spPr>
          <a:xfrm>
            <a:off x="4639180" y="6334414"/>
            <a:ext cx="324000" cy="1440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E74FAF0-A698-4620-8851-27C98C61102C}"/>
              </a:ext>
            </a:extLst>
          </p:cNvPr>
          <p:cNvSpPr/>
          <p:nvPr/>
        </p:nvSpPr>
        <p:spPr>
          <a:xfrm>
            <a:off x="152087" y="7740751"/>
            <a:ext cx="656875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1. Phylogenetic position of the strains used in this study. The strains used in this study are designated by the red square. The clinical strains isolated from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ulmonary disease are classified into two groups: (1) typical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group (TMI), (2)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ra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MP)-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indicus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anii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MIP) group</a:t>
            </a:r>
            <a:r>
              <a:rPr lang="ja-JP" alt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[Reference 19]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5548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1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3</cp:revision>
  <dcterms:created xsi:type="dcterms:W3CDTF">2022-12-07T03:50:42Z</dcterms:created>
  <dcterms:modified xsi:type="dcterms:W3CDTF">2023-03-31T06:12:28Z</dcterms:modified>
</cp:coreProperties>
</file>